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29" r:id="rId2"/>
    <p:sldId id="330" r:id="rId3"/>
    <p:sldId id="332" r:id="rId4"/>
    <p:sldId id="267" r:id="rId5"/>
    <p:sldId id="268" r:id="rId6"/>
    <p:sldId id="269" r:id="rId7"/>
    <p:sldId id="270" r:id="rId8"/>
    <p:sldId id="271" r:id="rId9"/>
    <p:sldId id="273" r:id="rId10"/>
    <p:sldId id="274" r:id="rId11"/>
    <p:sldId id="275" r:id="rId12"/>
    <p:sldId id="276" r:id="rId13"/>
    <p:sldId id="277" r:id="rId1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037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232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25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954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829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05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504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762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786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584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645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4443A-FDBB-774D-B471-941F3E8B813B}" type="datetimeFigureOut">
              <a:rPr lang="en-US" smtClean="0"/>
              <a:t>11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723C6-E3E8-8A4B-B38F-1E16B1BB0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949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911BD30B-F1BD-01AA-0B52-F89F47F257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043714" y="3108016"/>
            <a:ext cx="8945427" cy="29279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A48EA82-073B-293A-30FB-FC74EC421404}"/>
              </a:ext>
            </a:extLst>
          </p:cNvPr>
          <p:cNvSpPr txBox="1"/>
          <p:nvPr/>
        </p:nvSpPr>
        <p:spPr>
          <a:xfrm rot="16200000">
            <a:off x="-2027583" y="5923722"/>
            <a:ext cx="5168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S1a. Estimated Kinship Matrix</a:t>
            </a:r>
          </a:p>
        </p:txBody>
      </p:sp>
    </p:spTree>
    <p:extLst>
      <p:ext uri="{BB962C8B-B14F-4D97-AF65-F5344CB8AC3E}">
        <p14:creationId xmlns:p14="http://schemas.microsoft.com/office/powerpoint/2010/main" val="18377638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 rot="16200000"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 rot="16200000">
            <a:off x="-669758" y="7141400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 rot="16200000">
            <a:off x="535694" y="4402721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Male 3 Pedigree</a:t>
            </a:r>
          </a:p>
        </p:txBody>
      </p:sp>
      <p:pic>
        <p:nvPicPr>
          <p:cNvPr id="4" name="Picture 3" descr="Diagram, engineering drawing&#10;&#10;Description automatically generated">
            <a:extLst>
              <a:ext uri="{FF2B5EF4-FFF2-40B4-BE49-F238E27FC236}">
                <a16:creationId xmlns:a16="http://schemas.microsoft.com/office/drawing/2014/main" id="{119A513D-ED74-6444-AC9C-F7F426CBC2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59928" y="2763521"/>
            <a:ext cx="7823781" cy="3651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08585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 rot="16200000"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 rot="16200000">
            <a:off x="-669758" y="7141400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 rot="16200000">
            <a:off x="535694" y="4402721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Female 1 Pedigree</a:t>
            </a:r>
          </a:p>
        </p:txBody>
      </p:sp>
      <p:pic>
        <p:nvPicPr>
          <p:cNvPr id="3" name="Picture 2" descr="Diagram, engineering drawing&#10;&#10;Description automatically generated">
            <a:extLst>
              <a:ext uri="{FF2B5EF4-FFF2-40B4-BE49-F238E27FC236}">
                <a16:creationId xmlns:a16="http://schemas.microsoft.com/office/drawing/2014/main" id="{4881F633-AE5A-FE47-92D3-F85BB6D85C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290280" y="3270795"/>
            <a:ext cx="7815615" cy="3126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5045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 rot="16200000"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 rot="16200000">
            <a:off x="-669758" y="7141398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21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 rot="16200000">
            <a:off x="535694" y="4402721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Female 2 Pedigree</a:t>
            </a:r>
          </a:p>
        </p:txBody>
      </p:sp>
      <p:pic>
        <p:nvPicPr>
          <p:cNvPr id="4" name="Picture 3" descr="Diagram, engineering drawing&#10;&#10;Description automatically generated">
            <a:extLst>
              <a:ext uri="{FF2B5EF4-FFF2-40B4-BE49-F238E27FC236}">
                <a16:creationId xmlns:a16="http://schemas.microsoft.com/office/drawing/2014/main" id="{5357B376-518E-9C40-A4BD-B51BBEC807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884964" y="3289513"/>
            <a:ext cx="8740768" cy="2719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55563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 rot="16200000"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 rot="16200000">
            <a:off x="-792711" y="7141554"/>
            <a:ext cx="28617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</a:t>
            </a:r>
            <a:r>
              <a:rPr lang="en-US" sz="1600" b="1">
                <a:latin typeface="Avenir Book" panose="02000503020000020003" pitchFamily="2" charset="0"/>
              </a:rPr>
              <a:t>figure S1j</a:t>
            </a:r>
            <a:endParaRPr lang="en-US" sz="1600" b="1" dirty="0">
              <a:latin typeface="Avenir Book" panose="02000503020000020003" pitchFamily="2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 rot="16200000">
            <a:off x="351585" y="4402722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Female 3 Pedigree</a:t>
            </a:r>
          </a:p>
        </p:txBody>
      </p:sp>
      <p:pic>
        <p:nvPicPr>
          <p:cNvPr id="3" name="Picture 2" descr="Diagram, engineering drawing&#10;&#10;Description automatically generated">
            <a:extLst>
              <a:ext uri="{FF2B5EF4-FFF2-40B4-BE49-F238E27FC236}">
                <a16:creationId xmlns:a16="http://schemas.microsoft.com/office/drawing/2014/main" id="{D4740C1B-8271-964A-BA89-5FA1B4C20B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293975" y="2506931"/>
            <a:ext cx="7885198" cy="3679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3046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174C3D9D-1A4F-8709-ACED-522EB10567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054318" y="2905707"/>
            <a:ext cx="8973266" cy="33130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2E32A17-13B6-FAAC-FA20-A348A34691F9}"/>
              </a:ext>
            </a:extLst>
          </p:cNvPr>
          <p:cNvSpPr txBox="1"/>
          <p:nvPr/>
        </p:nvSpPr>
        <p:spPr>
          <a:xfrm rot="16200000">
            <a:off x="-2027583" y="5923722"/>
            <a:ext cx="5168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S1b. Actual  Kinship Matrix</a:t>
            </a:r>
          </a:p>
        </p:txBody>
      </p:sp>
    </p:spTree>
    <p:extLst>
      <p:ext uri="{BB962C8B-B14F-4D97-AF65-F5344CB8AC3E}">
        <p14:creationId xmlns:p14="http://schemas.microsoft.com/office/powerpoint/2010/main" val="1085928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F292963-1538-BC6B-1DC6-B9CC018F1BF4}"/>
              </a:ext>
            </a:extLst>
          </p:cNvPr>
          <p:cNvGraphicFramePr>
            <a:graphicFrameLocks noGrp="1"/>
          </p:cNvGraphicFramePr>
          <p:nvPr/>
        </p:nvGraphicFramePr>
        <p:xfrm>
          <a:off x="656491" y="408388"/>
          <a:ext cx="5775570" cy="7739946"/>
        </p:xfrm>
        <a:graphic>
          <a:graphicData uri="http://schemas.openxmlformats.org/drawingml/2006/table">
            <a:tbl>
              <a:tblPr/>
              <a:tblGrid>
                <a:gridCol w="641730">
                  <a:extLst>
                    <a:ext uri="{9D8B030D-6E8A-4147-A177-3AD203B41FA5}">
                      <a16:colId xmlns:a16="http://schemas.microsoft.com/office/drawing/2014/main" val="198046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585574759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3248797990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1594547910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40855960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4238212671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1685219238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3453873653"/>
                    </a:ext>
                  </a:extLst>
                </a:gridCol>
                <a:gridCol w="641730">
                  <a:extLst>
                    <a:ext uri="{9D8B030D-6E8A-4147-A177-3AD203B41FA5}">
                      <a16:colId xmlns:a16="http://schemas.microsoft.com/office/drawing/2014/main" val="1793438891"/>
                    </a:ext>
                  </a:extLst>
                </a:gridCol>
              </a:tblGrid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TK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7orf9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JC1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XC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1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1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AP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891474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C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orf20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L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XC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1C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K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987503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CC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0orf9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M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P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D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3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EC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5227564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2orf2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SC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AS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P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P5K1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B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1961817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A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orf3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SG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CAT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8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TX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BR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7945713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C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6orf15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SP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B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8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53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BR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31639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N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6orf20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TN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LR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54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J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4340238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AMTS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9orf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M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T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LRAP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59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RMT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LN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7577152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K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1C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L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K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59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ARG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LX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6475758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R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1D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IF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MP1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A</a:t>
                      </a:r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59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P1R1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EM4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9850188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RB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1G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IF4H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G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MN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6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61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AG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PO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5126978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GF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1H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MO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PR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P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6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65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E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NC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2538733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AP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1S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ML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G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AT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1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75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EN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NI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1360126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MS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2D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PP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PH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P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76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PN1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NT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9239736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PH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A2D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R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P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RM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87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1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M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6972222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K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NB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R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A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Z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0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87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E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SG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5351320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K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CR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I2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A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DD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0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9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F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C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188740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KRD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R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I2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A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2K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0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KRN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C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24876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3M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MK2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YA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AB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2K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L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M2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C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410534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MK2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117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D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M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RPL2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F13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C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363052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A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MK2D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S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D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D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2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ED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RP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C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1556968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MK2G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B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E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D13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2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PC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TL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M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9743097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C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Q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E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T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3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H1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YR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M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0031737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C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KB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H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X3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3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H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5D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2363688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C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KT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H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3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H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N1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R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292030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E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T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IP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0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4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H7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N4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NDC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921410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P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DC7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XC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I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0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4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L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N5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MP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550996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ID3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NH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XN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J1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2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4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L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TD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NGL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928523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R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K1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BP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J1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3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4C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LK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XN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CA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9969565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T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TP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J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3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6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LK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CD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C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8758362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G1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TR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E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J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3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7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O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OC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KORC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257993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OH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CHD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J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3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76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OZ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2A1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PS13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2217041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D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4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76C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P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6A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TI1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6650592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A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M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B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4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7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RNA0008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9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T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4988854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A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CA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CX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4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38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E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APC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NK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2879890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A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CN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NS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4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1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X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ORA4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7065622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OT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J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4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1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ORA5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W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7551915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B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27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JA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4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2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SCH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T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FPM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6490100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1B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3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B1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5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2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X2-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S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22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900264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2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4A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C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5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3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E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SH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22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5305784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2A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4A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D1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5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3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S1AP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MBPL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23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0279503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2A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Z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ID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M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5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5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CH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RD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28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0855984"/>
                  </a:ext>
                </a:extLst>
              </a:tr>
              <a:tr h="125967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2B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YA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M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N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8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5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HP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RANB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99461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2B2</a:t>
                      </a:r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SRP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N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N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8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8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P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N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9121554"/>
                  </a:ext>
                </a:extLst>
              </a:tr>
              <a:tr h="122758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L2L1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ST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PBP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Q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8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8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D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NE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8602437"/>
                  </a:ext>
                </a:extLst>
              </a:tr>
              <a:tr h="154239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F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N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AA179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8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8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G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NE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6651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X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N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HL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9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87B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N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F1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2200110"/>
                  </a:ext>
                </a:extLst>
              </a:tr>
              <a:tr h="164343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LRD3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N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AS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9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88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MR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S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1006512"/>
                  </a:ext>
                </a:extLst>
              </a:tr>
              <a:tr h="156308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H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CL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14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19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8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NK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516589"/>
                  </a:ext>
                </a:extLst>
              </a:tr>
              <a:tr h="125046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R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CS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16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0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SK9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20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6787864"/>
                  </a:ext>
                </a:extLst>
              </a:tr>
              <a:tr h="115486"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F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HCR24</a:t>
                      </a:r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PX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T17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202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491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1A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5</a:t>
                      </a:r>
                      <a:endParaRPr lang="en-US" sz="80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/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5615119"/>
                  </a:ext>
                </a:extLst>
              </a:tr>
              <a:tr h="166720">
                <a:tc gridSpan="9">
                  <a:txBody>
                    <a:bodyPr/>
                    <a:lstStyle/>
                    <a:p>
                      <a:pPr rtl="0" fontAlgn="b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ementary Table 2: Genes known to be associated with human cardiovascular disease.</a:t>
                      </a:r>
                      <a:endParaRPr lang="en-US" sz="800" dirty="0">
                        <a:effectLst/>
                      </a:endParaRPr>
                    </a:p>
                  </a:txBody>
                  <a:tcPr marL="12981" marR="12981" marT="12981" marB="12981" anchor="b">
                    <a:lnL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057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7855227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101A7392-6157-1C3C-C513-17A83FBF39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7702" y="2326375"/>
            <a:ext cx="184731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en-US" altLang="en-US">
                <a:latin typeface="Arial" panose="020B0604020202020204" pitchFamily="34" charset="0"/>
              </a:rPr>
            </a:br>
            <a:endParaRPr lang="en-US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37988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schematic&#10;&#10;Description automatically generated">
            <a:extLst>
              <a:ext uri="{FF2B5EF4-FFF2-40B4-BE49-F238E27FC236}">
                <a16:creationId xmlns:a16="http://schemas.microsoft.com/office/drawing/2014/main" id="{E9212A16-982C-244B-8624-5E28F389E6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02953"/>
            <a:ext cx="6858000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EF7CBA-4C2A-CD41-875C-5D743AC48454}"/>
              </a:ext>
            </a:extLst>
          </p:cNvPr>
          <p:cNvSpPr txBox="1"/>
          <p:nvPr/>
        </p:nvSpPr>
        <p:spPr>
          <a:xfrm>
            <a:off x="2" y="921581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1C057F-DA2E-FE43-AEC5-66359CBBE982}"/>
              </a:ext>
            </a:extLst>
          </p:cNvPr>
          <p:cNvSpPr txBox="1"/>
          <p:nvPr/>
        </p:nvSpPr>
        <p:spPr>
          <a:xfrm>
            <a:off x="1869520" y="2301698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Dolly (195) Pedigree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E1458AE5-04C3-5948-9245-377B640CB6F8}"/>
              </a:ext>
            </a:extLst>
          </p:cNvPr>
          <p:cNvGrpSpPr/>
          <p:nvPr/>
        </p:nvGrpSpPr>
        <p:grpSpPr>
          <a:xfrm>
            <a:off x="5338022" y="7093396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D7C676C-1352-694D-A458-9779FF82AD38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C92690C8-F586-9647-9BB1-97C286AF76F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E2583E0-5A73-E04E-AF93-678BDDE8ADB2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93BBC217-4477-DC4A-B17C-3F58C71FBA4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BE24DF7-9AE2-4747-90D1-C6D327E3C5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841133C3-E46F-BB46-AAE1-363EB83F3E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D733B2CA-9825-5645-B400-C6A400F06879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FE875757-0962-D04D-B64A-47FBD881A2F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D64C0D0-BF2A-EF40-9D5D-6DA70FE5A09B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E9F1185-2EB4-804D-87A4-34CB9085D4C8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44616F6-5BE7-DC4B-A681-E0BB4CD5FDB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252927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FF6E7CDC-7B81-1B4D-93B8-AFCBB2EC5C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806057"/>
            <a:ext cx="6858000" cy="548640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>
            <a:off x="196772" y="412295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>
            <a:off x="2066290" y="1792412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Abe (52) Pedigree</a:t>
            </a:r>
          </a:p>
        </p:txBody>
      </p:sp>
    </p:spTree>
    <p:extLst>
      <p:ext uri="{BB962C8B-B14F-4D97-AF65-F5344CB8AC3E}">
        <p14:creationId xmlns:p14="http://schemas.microsoft.com/office/powerpoint/2010/main" val="4614631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Diagram&#10;&#10;Description automatically generated">
            <a:extLst>
              <a:ext uri="{FF2B5EF4-FFF2-40B4-BE49-F238E27FC236}">
                <a16:creationId xmlns:a16="http://schemas.microsoft.com/office/drawing/2014/main" id="{34002E99-F8F5-2E41-ABA3-D0D7D2E6B7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14974"/>
            <a:ext cx="6858000" cy="548640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>
            <a:off x="196772" y="412293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>
            <a:off x="2066290" y="1792412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Tzambo (440) Pedigree</a:t>
            </a:r>
          </a:p>
        </p:txBody>
      </p:sp>
    </p:spTree>
    <p:extLst>
      <p:ext uri="{BB962C8B-B14F-4D97-AF65-F5344CB8AC3E}">
        <p14:creationId xmlns:p14="http://schemas.microsoft.com/office/powerpoint/2010/main" val="9739427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A1969450-401D-4344-8BDE-18A9141D84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48711"/>
            <a:ext cx="6858000" cy="548640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>
            <a:off x="196772" y="412295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>
            <a:off x="2066290" y="1792412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Porta (64) Pedigree</a:t>
            </a:r>
          </a:p>
        </p:txBody>
      </p:sp>
    </p:spTree>
    <p:extLst>
      <p:ext uri="{BB962C8B-B14F-4D97-AF65-F5344CB8AC3E}">
        <p14:creationId xmlns:p14="http://schemas.microsoft.com/office/powerpoint/2010/main" val="29127403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 rot="16200000"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 rot="16200000">
            <a:off x="-720033" y="7375538"/>
            <a:ext cx="26158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 rot="16200000">
            <a:off x="535694" y="4402721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Male 1 Pedigree</a:t>
            </a:r>
          </a:p>
        </p:txBody>
      </p:sp>
      <p:pic>
        <p:nvPicPr>
          <p:cNvPr id="4" name="Picture 3" descr="A picture containing text, sky, antenna&#10;&#10;Description automatically generated">
            <a:extLst>
              <a:ext uri="{FF2B5EF4-FFF2-40B4-BE49-F238E27FC236}">
                <a16:creationId xmlns:a16="http://schemas.microsoft.com/office/drawing/2014/main" id="{35B44810-4370-3143-9B34-2A16E7F09D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439755" y="3190417"/>
            <a:ext cx="8881592" cy="2763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72535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3626151-54F3-2B46-928A-53D1CDAE3BA9}"/>
              </a:ext>
            </a:extLst>
          </p:cNvPr>
          <p:cNvGrpSpPr/>
          <p:nvPr/>
        </p:nvGrpSpPr>
        <p:grpSpPr>
          <a:xfrm rot="16200000">
            <a:off x="5256997" y="7263920"/>
            <a:ext cx="1519978" cy="954107"/>
            <a:chOff x="5338022" y="7093394"/>
            <a:chExt cx="1519978" cy="95410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F074C38-AF3D-2640-AA01-15089191EF5D}"/>
                </a:ext>
              </a:extLst>
            </p:cNvPr>
            <p:cNvSpPr/>
            <p:nvPr/>
          </p:nvSpPr>
          <p:spPr>
            <a:xfrm>
              <a:off x="5412263" y="7258963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1F227ED-5760-2F47-94FE-FD89868794F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2263" y="7144316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26A862B-72CD-A642-9A4C-AC1497D7EC7D}"/>
                </a:ext>
              </a:extLst>
            </p:cNvPr>
            <p:cNvSpPr/>
            <p:nvPr/>
          </p:nvSpPr>
          <p:spPr>
            <a:xfrm>
              <a:off x="5460348" y="739377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38D512F-2A6D-A441-B170-C5CD7C5BAE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5223" y="7393774"/>
              <a:ext cx="73152" cy="73152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62F101E-1B5E-774D-A65C-FD5E4373AC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38022" y="7380431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4560A4-4CD1-574B-93DB-DBD0E1358D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44449" y="7379583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2763FBA-52F7-C140-84A3-60DFF7007F76}"/>
                </a:ext>
              </a:extLst>
            </p:cNvPr>
            <p:cNvSpPr/>
            <p:nvPr/>
          </p:nvSpPr>
          <p:spPr>
            <a:xfrm>
              <a:off x="5459496" y="7530850"/>
              <a:ext cx="73152" cy="731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C53C1B9-0D7F-A447-AB41-C36DC65A3D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54371" y="7530850"/>
              <a:ext cx="73152" cy="73152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349B1-0C2B-4D4B-BCD3-95020B15100F}"/>
                </a:ext>
              </a:extLst>
            </p:cNvPr>
            <p:cNvSpPr txBox="1"/>
            <p:nvPr/>
          </p:nvSpPr>
          <p:spPr>
            <a:xfrm>
              <a:off x="5484119" y="7093394"/>
              <a:ext cx="137388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venir Book" panose="02000503020000020003" pitchFamily="2" charset="0"/>
                </a:rPr>
                <a:t>Fe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Male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Deceas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Cardiovascular affected</a:t>
              </a:r>
            </a:p>
            <a:p>
              <a:r>
                <a:rPr lang="en-US" sz="800">
                  <a:latin typeface="Avenir Book" panose="02000503020000020003" pitchFamily="2" charset="0"/>
                </a:rPr>
                <a:t>Non-viable offspring (aborted pregnancy or early infancy death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F9ADCA1-7D9C-204D-AA7B-DE6E211EB129}"/>
                </a:ext>
              </a:extLst>
            </p:cNvPr>
            <p:cNvSpPr/>
            <p:nvPr/>
          </p:nvSpPr>
          <p:spPr>
            <a:xfrm rot="2710393">
              <a:off x="5401581" y="7670504"/>
              <a:ext cx="73152" cy="73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0C547B4-17AF-4041-8434-C74C39632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492" y="7649752"/>
              <a:ext cx="105125" cy="9983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AAF7E7FC-46FD-5546-8D83-F95708E8D43C}"/>
              </a:ext>
            </a:extLst>
          </p:cNvPr>
          <p:cNvSpPr txBox="1"/>
          <p:nvPr/>
        </p:nvSpPr>
        <p:spPr>
          <a:xfrm rot="16200000">
            <a:off x="-669758" y="7264508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venir Book" panose="02000503020000020003" pitchFamily="2" charset="0"/>
              </a:rPr>
              <a:t>Supplementary figure S1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6F94C0-FDAD-3442-9BB6-C3E59D70A01D}"/>
              </a:ext>
            </a:extLst>
          </p:cNvPr>
          <p:cNvSpPr txBox="1"/>
          <p:nvPr/>
        </p:nvSpPr>
        <p:spPr>
          <a:xfrm rot="16200000">
            <a:off x="535694" y="4402721"/>
            <a:ext cx="26158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venir Book" panose="02000503020000020003" pitchFamily="2" charset="0"/>
              </a:rPr>
              <a:t>Male 2 Pedigree</a:t>
            </a:r>
          </a:p>
        </p:txBody>
      </p:sp>
      <p:pic>
        <p:nvPicPr>
          <p:cNvPr id="3" name="Picture 2" descr="A picture containing text, sky, snow, outdoor&#10;&#10;Description automatically generated">
            <a:extLst>
              <a:ext uri="{FF2B5EF4-FFF2-40B4-BE49-F238E27FC236}">
                <a16:creationId xmlns:a16="http://schemas.microsoft.com/office/drawing/2014/main" id="{27D4419B-5490-474B-92DE-5700DDD5ED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619047" y="3467426"/>
            <a:ext cx="8486475" cy="2376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2151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698</Words>
  <Application>Microsoft Macintosh PowerPoint</Application>
  <PresentationFormat>Letter Paper (8.5x11 in)</PresentationFormat>
  <Paragraphs>525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Avenir Book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Edward Gorzynski</dc:creator>
  <cp:lastModifiedBy>John Edward Gorzynski</cp:lastModifiedBy>
  <cp:revision>3</cp:revision>
  <dcterms:created xsi:type="dcterms:W3CDTF">2023-11-06T23:54:50Z</dcterms:created>
  <dcterms:modified xsi:type="dcterms:W3CDTF">2023-11-07T00:06:18Z</dcterms:modified>
</cp:coreProperties>
</file>